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B7E61F-116F-4E97-9D38-A9C1173CCD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2CE17-86DE-475B-A984-215D1E4CC4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1029E-D375-4624-A4C3-8C2755624D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C03A3-7E93-44C8-A561-EA4D6AA9C6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69750-D629-47C1-89B7-2727532C90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50C1AD-A2FA-4BDC-9729-5DCE41A7F0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5F5733-105D-452D-BB34-91FB9E1E8D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F91336-17A5-4DDD-8C8A-4E305AEE8C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06177-A21F-427D-A3FF-F87F1804D3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1EAE14-3AE7-4EC0-A960-537A7493D1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E7F1D4-C267-41CD-B1BE-7FF984D8EB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8C599-4DF8-4577-97DE-262FB53A9C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E98A35-CFC0-40B4-916E-3C1216E08BBB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16080" y="2978280"/>
          <a:ext cx="6095880" cy="1117440"/>
        </p:xfrm>
        <a:graphic>
          <a:graphicData uri="http://schemas.openxmlformats.org/drawingml/2006/table">
            <a:tbl>
              <a:tblPr/>
              <a:tblGrid>
                <a:gridCol w="554040"/>
                <a:gridCol w="554040"/>
                <a:gridCol w="554040"/>
                <a:gridCol w="554040"/>
                <a:gridCol w="554040"/>
                <a:gridCol w="555480"/>
                <a:gridCol w="554040"/>
                <a:gridCol w="554040"/>
                <a:gridCol w="554040"/>
                <a:gridCol w="554040"/>
                <a:gridCol w="554040"/>
              </a:tblGrid>
              <a:tr h="558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1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+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58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1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+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1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+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1" lang="en-US" sz="2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+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6492600" y="3046320"/>
            <a:ext cx="2018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EGFR Mutatio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6492960" y="3608280"/>
            <a:ext cx="2034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KRAS Mutatio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125640" y="2184120"/>
            <a:ext cx="891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549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617040" y="2087280"/>
            <a:ext cx="10767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1975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1244520" y="2180160"/>
            <a:ext cx="907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226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1792080" y="2170800"/>
            <a:ext cx="907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441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2368440" y="2170800"/>
            <a:ext cx="907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520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2901960" y="2170800"/>
            <a:ext cx="907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596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3459240" y="2170800"/>
            <a:ext cx="907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661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 rot="16200000">
            <a:off x="3917520" y="2095200"/>
            <a:ext cx="10767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1437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4479480" y="2095200"/>
            <a:ext cx="10767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1838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5036760" y="2085840"/>
            <a:ext cx="10767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2122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5528520" y="2030400"/>
            <a:ext cx="1179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W900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1978200" y="914400"/>
            <a:ext cx="2819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NSCLC Cell Line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56" name=""/>
          <p:cNvGraphicFramePr/>
          <p:nvPr/>
        </p:nvGraphicFramePr>
        <p:xfrm>
          <a:off x="316080" y="4091040"/>
          <a:ext cx="6100560" cy="533160"/>
        </p:xfrm>
        <a:graphic>
          <a:graphicData uri="http://schemas.openxmlformats.org/drawingml/2006/table">
            <a:tbl>
              <a:tblPr/>
              <a:tblGrid>
                <a:gridCol w="554040"/>
                <a:gridCol w="555480"/>
                <a:gridCol w="554040"/>
                <a:gridCol w="554040"/>
                <a:gridCol w="552600"/>
                <a:gridCol w="558720"/>
                <a:gridCol w="554040"/>
                <a:gridCol w="550800"/>
                <a:gridCol w="554040"/>
                <a:gridCol w="539640"/>
                <a:gridCol w="573120"/>
              </a:tblGrid>
              <a:tr h="533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7" name=""/>
          <p:cNvSpPr/>
          <p:nvPr/>
        </p:nvSpPr>
        <p:spPr>
          <a:xfrm>
            <a:off x="6515640" y="4151160"/>
            <a:ext cx="25534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Erlotinib Sensitivit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363600" y="1504800"/>
            <a:ext cx="6019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59" name=""/>
          <p:cNvGraphicFramePr/>
          <p:nvPr/>
        </p:nvGraphicFramePr>
        <p:xfrm>
          <a:off x="301680" y="4819680"/>
          <a:ext cx="6100560" cy="533520"/>
        </p:xfrm>
        <a:graphic>
          <a:graphicData uri="http://schemas.openxmlformats.org/drawingml/2006/table">
            <a:tbl>
              <a:tblPr/>
              <a:tblGrid>
                <a:gridCol w="553680"/>
                <a:gridCol w="555480"/>
                <a:gridCol w="554040"/>
                <a:gridCol w="554040"/>
                <a:gridCol w="567000"/>
                <a:gridCol w="544320"/>
                <a:gridCol w="554040"/>
                <a:gridCol w="554040"/>
                <a:gridCol w="554040"/>
                <a:gridCol w="555840"/>
                <a:gridCol w="554040"/>
              </a:tblGrid>
              <a:tr h="533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Ad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Ad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Sq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Ad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Sq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AS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L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Ad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Ad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Ad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Sq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0" name=""/>
          <p:cNvSpPr/>
          <p:nvPr/>
        </p:nvSpPr>
        <p:spPr>
          <a:xfrm>
            <a:off x="6502680" y="487980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1c1c1c"/>
                </a:solidFill>
                <a:latin typeface="Arial"/>
              </a:rPr>
              <a:t>Histology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61" name=""/>
          <p:cNvGraphicFramePr/>
          <p:nvPr/>
        </p:nvGraphicFramePr>
        <p:xfrm>
          <a:off x="301680" y="5567400"/>
          <a:ext cx="6100560" cy="533160"/>
        </p:xfrm>
        <a:graphic>
          <a:graphicData uri="http://schemas.openxmlformats.org/drawingml/2006/table">
            <a:tbl>
              <a:tblPr/>
              <a:tblGrid>
                <a:gridCol w="553680"/>
                <a:gridCol w="555480"/>
                <a:gridCol w="554040"/>
                <a:gridCol w="554040"/>
                <a:gridCol w="567000"/>
                <a:gridCol w="544320"/>
                <a:gridCol w="554040"/>
                <a:gridCol w="554040"/>
                <a:gridCol w="554040"/>
                <a:gridCol w="555840"/>
                <a:gridCol w="554040"/>
              </a:tblGrid>
              <a:tr h="533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F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F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F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1c1c1c"/>
                          </a:solidFill>
                          <a:latin typeface="Arial"/>
                        </a:rPr>
                        <a:t>M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2" name=""/>
          <p:cNvSpPr/>
          <p:nvPr/>
        </p:nvSpPr>
        <p:spPr>
          <a:xfrm>
            <a:off x="6502680" y="5627520"/>
            <a:ext cx="1072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1c1c1c"/>
                </a:solidFill>
                <a:latin typeface="Arial"/>
              </a:rPr>
              <a:t>Gender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137880" y="117360"/>
            <a:ext cx="119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S-Table 1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7332120" y="144360"/>
            <a:ext cx="1636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Tang et al., BJC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15T04:45:16Z</dcterms:created>
  <dc:creator> Patrick Ma</dc:creator>
  <dc:description/>
  <dc:language>en-US</dc:language>
  <cp:lastModifiedBy>rmgzkm3</cp:lastModifiedBy>
  <dcterms:modified xsi:type="dcterms:W3CDTF">2008-07-21T10:57:32Z</dcterms:modified>
  <cp:revision>10</cp:revision>
  <dc:subject/>
  <dc:title>PowerPoint Presentation</dc:title>
</cp:coreProperties>
</file>